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3240088" cy="8640763"/>
  <p:notesSz cx="6858000" cy="100155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7F290D-4408-40B3-B29A-F759B813414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162000" y="345960"/>
            <a:ext cx="2916000" cy="144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162000" y="2016000"/>
            <a:ext cx="291600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162000" y="4994640"/>
            <a:ext cx="291600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13CFAB-E7A1-4330-A4B4-21722BCAAF0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162000" y="345960"/>
            <a:ext cx="2916000" cy="144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162000" y="2016000"/>
            <a:ext cx="142272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1656360" y="2016000"/>
            <a:ext cx="142272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162000" y="4994640"/>
            <a:ext cx="142272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1656360" y="4994640"/>
            <a:ext cx="142272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AF8736-BBEF-41BA-9A05-10E8691C2CA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162000" y="345960"/>
            <a:ext cx="2916000" cy="144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162000" y="2016000"/>
            <a:ext cx="93888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78000"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148040" y="2016000"/>
            <a:ext cx="93888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78000"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2134440" y="2016000"/>
            <a:ext cx="93888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78000"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162000" y="4994640"/>
            <a:ext cx="93888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78000"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148040" y="4994640"/>
            <a:ext cx="93888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78000"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2134440" y="4994640"/>
            <a:ext cx="93888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78000"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D39F46-32FC-49C6-8F38-CE4FA09FB51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162000" y="345960"/>
            <a:ext cx="2916000" cy="144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162000" y="2016000"/>
            <a:ext cx="2916000" cy="5702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8D1976-5304-4652-B562-CA166A534BC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162000" y="345960"/>
            <a:ext cx="2916000" cy="144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162000" y="2016000"/>
            <a:ext cx="2916000" cy="570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A4E3DF-7DEA-4D19-A8D0-C4CD6DA90C6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162000" y="345960"/>
            <a:ext cx="2916000" cy="144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162000" y="2016000"/>
            <a:ext cx="1422720" cy="570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1656360" y="2016000"/>
            <a:ext cx="1422720" cy="570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23F378-6DA0-40EA-B0CC-EABE8289E77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162000" y="345960"/>
            <a:ext cx="2916000" cy="144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4AF1F6-3C67-40B2-B35A-04867E2B9C2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162000" y="345960"/>
            <a:ext cx="2916000" cy="6676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AD279D-EAB6-4EFF-89CC-93482CAE874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162000" y="345960"/>
            <a:ext cx="2916000" cy="144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162000" y="2016000"/>
            <a:ext cx="142272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1656360" y="2016000"/>
            <a:ext cx="1422720" cy="570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162000" y="4994640"/>
            <a:ext cx="142272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2E77AA-031F-4D1A-8ACC-5FD52794E8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162000" y="345960"/>
            <a:ext cx="2916000" cy="144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162000" y="2016000"/>
            <a:ext cx="1422720" cy="570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1656360" y="2016000"/>
            <a:ext cx="142272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1656360" y="4994640"/>
            <a:ext cx="142272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E2BCB6-5F40-4AEE-B6A5-007AA86118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162000" y="345960"/>
            <a:ext cx="2916000" cy="144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162000" y="2016000"/>
            <a:ext cx="142272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1656360" y="2016000"/>
            <a:ext cx="142272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162000" y="4994640"/>
            <a:ext cx="291600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5F320B-D065-43CB-ACEB-803B14AA1A0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162000" y="345960"/>
            <a:ext cx="2916000" cy="144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162000" y="2016000"/>
            <a:ext cx="2916000" cy="570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66000"/>
          </a:bodyPr>
          <a:p>
            <a:pPr marL="2260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490320" indent="-1886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754200" indent="-15084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055880" indent="-150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1357560" indent="-15084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1357560" indent="-15084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1357560" indent="-15084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161640" y="8008560"/>
            <a:ext cx="755640" cy="460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l-PL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106280" y="8008560"/>
            <a:ext cx="1027080" cy="460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2322000" y="8008560"/>
            <a:ext cx="755640" cy="460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l-PL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7665AC2-9486-4859-A7E5-AB8BD35E9CAE}" type="slidenum">
              <a:rPr b="0" lang="pl-PL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upa 40"/>
          <p:cNvGrpSpPr/>
          <p:nvPr/>
        </p:nvGrpSpPr>
        <p:grpSpPr>
          <a:xfrm>
            <a:off x="426960" y="728640"/>
            <a:ext cx="2444040" cy="1418760"/>
            <a:chOff x="426960" y="728640"/>
            <a:chExt cx="2444040" cy="1418760"/>
          </a:xfrm>
        </p:grpSpPr>
        <p:grpSp>
          <p:nvGrpSpPr>
            <p:cNvPr id="42" name="Group 1058"/>
            <p:cNvGrpSpPr/>
            <p:nvPr/>
          </p:nvGrpSpPr>
          <p:grpSpPr>
            <a:xfrm>
              <a:off x="426960" y="1258200"/>
              <a:ext cx="2099880" cy="838440"/>
              <a:chOff x="426960" y="1258200"/>
              <a:chExt cx="2099880" cy="838440"/>
            </a:xfrm>
          </p:grpSpPr>
          <p:pic>
            <p:nvPicPr>
              <p:cNvPr id="43" name="Picture 1059" descr=""/>
              <p:cNvPicPr/>
              <p:nvPr/>
            </p:nvPicPr>
            <p:blipFill>
              <a:blip r:embed="rId1"/>
              <a:stretch/>
            </p:blipFill>
            <p:spPr>
              <a:xfrm>
                <a:off x="426960" y="1258200"/>
                <a:ext cx="1859400" cy="8384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4" name="Picture 1060" descr=""/>
              <p:cNvPicPr/>
              <p:nvPr/>
            </p:nvPicPr>
            <p:blipFill>
              <a:blip r:embed="rId2"/>
              <a:stretch/>
            </p:blipFill>
            <p:spPr>
              <a:xfrm>
                <a:off x="2284200" y="1258200"/>
                <a:ext cx="242640" cy="83844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45" name="Text Box 1097"/>
            <p:cNvSpPr/>
            <p:nvPr/>
          </p:nvSpPr>
          <p:spPr>
            <a:xfrm rot="16200000">
              <a:off x="345240" y="938880"/>
              <a:ext cx="5252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X4E1a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 Box 1098"/>
            <p:cNvSpPr/>
            <p:nvPr/>
          </p:nvSpPr>
          <p:spPr>
            <a:xfrm rot="16200000">
              <a:off x="631440" y="907560"/>
              <a:ext cx="5893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X4E1a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 Box 1099"/>
            <p:cNvSpPr/>
            <p:nvPr/>
          </p:nvSpPr>
          <p:spPr>
            <a:xfrm rot="16200000">
              <a:off x="943920" y="907560"/>
              <a:ext cx="5893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X4E1a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 Box 1100"/>
            <p:cNvSpPr/>
            <p:nvPr/>
          </p:nvSpPr>
          <p:spPr>
            <a:xfrm rot="16200000">
              <a:off x="1251000" y="907560"/>
              <a:ext cx="5893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X4E1a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 Box 1101"/>
            <p:cNvSpPr/>
            <p:nvPr/>
          </p:nvSpPr>
          <p:spPr>
            <a:xfrm rot="16200000">
              <a:off x="1553400" y="907560"/>
              <a:ext cx="5893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X4E1a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 Box 1102"/>
            <p:cNvSpPr/>
            <p:nvPr/>
          </p:nvSpPr>
          <p:spPr>
            <a:xfrm rot="16200000">
              <a:off x="1850760" y="907560"/>
              <a:ext cx="5893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X4E1a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 Box 1054"/>
            <p:cNvSpPr/>
            <p:nvPr/>
          </p:nvSpPr>
          <p:spPr>
            <a:xfrm>
              <a:off x="2458440" y="1618200"/>
              <a:ext cx="4046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25.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 Box 1056"/>
            <p:cNvSpPr/>
            <p:nvPr/>
          </p:nvSpPr>
          <p:spPr>
            <a:xfrm>
              <a:off x="2448720" y="1916280"/>
              <a:ext cx="4046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8.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 Box 1055"/>
            <p:cNvSpPr/>
            <p:nvPr/>
          </p:nvSpPr>
          <p:spPr>
            <a:xfrm>
              <a:off x="2458440" y="1373040"/>
              <a:ext cx="4046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35.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 Box 1057"/>
            <p:cNvSpPr/>
            <p:nvPr/>
          </p:nvSpPr>
          <p:spPr>
            <a:xfrm>
              <a:off x="2475000" y="1046880"/>
              <a:ext cx="38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kDa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 Box 1062"/>
            <p:cNvSpPr/>
            <p:nvPr/>
          </p:nvSpPr>
          <p:spPr>
            <a:xfrm>
              <a:off x="2466360" y="1200240"/>
              <a:ext cx="4046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45.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 Box 1103"/>
            <p:cNvSpPr/>
            <p:nvPr/>
          </p:nvSpPr>
          <p:spPr>
            <a:xfrm rot="16200000">
              <a:off x="2223000" y="1019880"/>
              <a:ext cx="3834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MW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aphicFrame>
        <p:nvGraphicFramePr>
          <p:cNvPr id="57" name=""/>
          <p:cNvGraphicFramePr/>
          <p:nvPr/>
        </p:nvGraphicFramePr>
        <p:xfrm>
          <a:off x="108000" y="2422440"/>
          <a:ext cx="3024000" cy="1874880"/>
        </p:xfrm>
        <a:graphic>
          <a:graphicData uri="http://schemas.openxmlformats.org/drawingml/2006/table">
            <a:tbl>
              <a:tblPr/>
              <a:tblGrid>
                <a:gridCol w="657000"/>
                <a:gridCol w="2367000"/>
              </a:tblGrid>
              <a:tr h="50544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Name of mutated protei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Mutated positions in XeIF4E1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112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X4E1a1</a:t>
                      </a:r>
                      <a:r>
                        <a:rPr b="0" lang="pl-PL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E101S</a:t>
                      </a:r>
                      <a:r>
                        <a:rPr b="0" lang="pl-PL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112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X4E1a1’</a:t>
                      </a:r>
                      <a:r>
                        <a:rPr b="0" lang="pl-PL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K102R</a:t>
                      </a:r>
                      <a:r>
                        <a:rPr b="0" lang="pl-PL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112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X4E1a2</a:t>
                      </a:r>
                      <a:r>
                        <a:rPr b="0" lang="pl-PL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E101S/K102R</a:t>
                      </a:r>
                      <a:r>
                        <a:rPr b="0" lang="pl-PL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112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X4E1a3</a:t>
                      </a:r>
                      <a:r>
                        <a:rPr b="0" lang="pl-PL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E101S/K102R/S195A</a:t>
                      </a:r>
                      <a:r>
                        <a:rPr b="0" lang="pl-PL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112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X4E1a4</a:t>
                      </a:r>
                      <a:r>
                        <a:rPr b="0" lang="pl-PL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E101S/K102R/S195A/M82S</a:t>
                      </a:r>
                      <a:r>
                        <a:rPr b="0" lang="pl-PL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112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X4E1a6</a:t>
                      </a:r>
                      <a:r>
                        <a:rPr b="0" lang="pl-PL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E101S/K102R/S195A/M82S/T206L/T207S</a:t>
                      </a:r>
                      <a:r>
                        <a:rPr b="0" lang="pl-PL" sz="9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8" name="pole tekstowe 7"/>
          <p:cNvSpPr/>
          <p:nvPr/>
        </p:nvSpPr>
        <p:spPr>
          <a:xfrm>
            <a:off x="17640" y="652320"/>
            <a:ext cx="522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Arial"/>
                <a:ea typeface="Arial"/>
              </a:rPr>
              <a:t>(a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pole tekstowe 7"/>
          <p:cNvSpPr/>
          <p:nvPr/>
        </p:nvSpPr>
        <p:spPr>
          <a:xfrm>
            <a:off x="17640" y="2101680"/>
            <a:ext cx="45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400" spc="-1" strike="noStrike">
                <a:solidFill>
                  <a:srgbClr val="000000"/>
                </a:solidFill>
                <a:latin typeface="Arial"/>
                <a:ea typeface="Arial"/>
              </a:rPr>
              <a:t>(b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4-09T14:05:47Z</dcterms:created>
  <dc:creator>Dorota Kubacka</dc:creator>
  <dc:description/>
  <dc:language>en-US</dc:language>
  <cp:lastModifiedBy>ZBUW2012_DK</cp:lastModifiedBy>
  <cp:lastPrinted>2014-04-09T15:02:13Z</cp:lastPrinted>
  <dcterms:modified xsi:type="dcterms:W3CDTF">2014-10-02T11:09:31Z</dcterms:modified>
  <cp:revision>20</cp:revision>
  <dc:subject/>
  <dc:title>Slajd 1</dc:title>
</cp:coreProperties>
</file>